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C2D4A5-900C-451E-BE0B-B4506A24B0F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E9E894-03F2-4013-825D-D6ED394052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D00B4A-1E87-48C9-BB2B-40154ADEEBE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3598BF-581B-44A1-BC04-0559FD4E57C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BBC52B-CB37-4708-BF95-FBA608064E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537E60-2F06-410F-AEF7-6A90525024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E8DFC7-10BE-4DD5-924B-8DEF70BC8F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D00C76-1C76-42D9-B433-E09C5F70E8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C920D5-AF53-443A-8355-E1E36A01B3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4CE5FD-98F7-4E64-89C2-47C9EC2207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947FB8-D498-4122-A0E4-268383513A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E0C96B-3E18-4FE0-BA50-2C682284FD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010D76-A025-40A4-B914-D2CD4D349C7F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6"/>
          <p:cNvSpPr/>
          <p:nvPr/>
        </p:nvSpPr>
        <p:spPr>
          <a:xfrm>
            <a:off x="458640" y="5154480"/>
            <a:ext cx="11201400" cy="146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aracteristics of rats after 10-week high-fat diet before STZ injection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-B: Body weight and blood glucose in the CD group and the HFD group after 10-week high fat diet before STZ injection. C-D: Insulin resistance test assessed by intraperitoneal glucose tolerance test and HOMA-IR. Black circle = the CD group, white triangle = the HFD group. E-G: TG/TC, Scr /BUN, ALT/ AST in the CD group and the HFD group after 10-week high-fat diet before STZ injection. Data are presented as mean ± SD (n = 12). *p&lt;0.05, compared to CD group. CD, chow diet group; HFD, high-fat diet group. IPGTT, intraperitoneal glucose tolerance test; TC, total cholesterol; TG, total triglycerides; Scr, serum creatinine; BUN, blood urea nitrogen; ALT, alanine transaminase; AST, aspartate transaminase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图片 1" descr=""/>
          <p:cNvPicPr/>
          <p:nvPr/>
        </p:nvPicPr>
        <p:blipFill>
          <a:blip r:embed="rId1"/>
          <a:stretch/>
        </p:blipFill>
        <p:spPr>
          <a:xfrm>
            <a:off x="1407960" y="1082520"/>
            <a:ext cx="8915400" cy="4071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文本框 4"/>
          <p:cNvSpPr/>
          <p:nvPr/>
        </p:nvSpPr>
        <p:spPr>
          <a:xfrm>
            <a:off x="658800" y="5168880"/>
            <a:ext cx="11201400" cy="11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2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rameters of rats after 12-week saxagliptin treatment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-C: TG/TC, Scr/BUN, ALT/AST in the NC, DM DM+Sax group after 12-week saxagliptin administration. Data are presented as mean ± SD (n = 12). *P&lt;0.05 vs. NC; #P&lt;0.05 vs. DM group. NC, nondiabetic group as normal control; DM, non-treated diabetic group; DM+Sax, diabetic rats with saxagliptin administration; TC, total cholesterol; TG, total triglycerides; BUN, blood urea nitrogen; Scr, serum creatinine; ALT, alanine transaminase; AST, aspartate transaminas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图片 1" descr=""/>
          <p:cNvPicPr/>
          <p:nvPr/>
        </p:nvPicPr>
        <p:blipFill>
          <a:blip r:embed="rId1"/>
          <a:stretch/>
        </p:blipFill>
        <p:spPr>
          <a:xfrm>
            <a:off x="1708200" y="2146320"/>
            <a:ext cx="8021520" cy="1942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2-06T09:44:12Z</dcterms:created>
  <dc:creator>常大鹏</dc:creator>
  <dc:description/>
  <dc:language>en-US</dc:language>
  <cp:lastModifiedBy>常大鹏</cp:lastModifiedBy>
  <dcterms:modified xsi:type="dcterms:W3CDTF">2017-07-07T06:51:11Z</dcterms:modified>
  <cp:revision>13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</Properties>
</file>